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81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EC8699-F11F-4B3F-8A60-3D02FD25F3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364F5F-F5BB-4759-8115-8DC03978B4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E8DA0-6BCC-4A66-9B5F-6C9029D35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12FF3B-BF78-4B9C-9177-0ABFC34AA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F063CE-5EC6-4A79-AC44-C8476D140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626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1827B7-A4DA-44E2-9994-BE28BA6BD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5F0AA8-E6A4-469D-B4A2-9995A180CB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E98E9D-5D43-4A25-A184-A5A4AA948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B34B70-B6A8-4A36-A2D4-6E32ED616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A8B9EF-2D61-499A-A3B7-06F18A3DF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778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7F3B09-5489-4D04-A6A1-A7E248147F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AD08D9-A06C-46C6-96C9-8E73B01E15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AB2BAE-3641-490D-B44B-CFC2DB6FB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01D55-3B74-4F0D-9E99-A9473FE6C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E39BE5-C58D-413D-9AAE-908B481F8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87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722AA-65DD-4047-A0B9-05AA7AE2B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3E104F-11B8-4C04-9692-973437DFB8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9F7CF8-0F7B-4EAD-BD68-E2855463D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99E381-8200-430B-A75A-FEE25E173E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A34D19-6E56-4E6A-B2CA-0A3E79D0B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055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D8AC6E-7DF3-403F-B1E9-CE26B5BFB6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DB3D05-7517-440C-859B-0244D2A4DE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640232-0BD2-4082-A309-691E50AE7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AC82F-F8DF-4DAC-8E45-2632BF222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36240E-0AAB-4C0D-9575-656E93A20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605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1215E3-5905-493A-910A-049456EC66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000D2D-D6D1-4CC9-B50A-21AE17EE1A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2402B9-7720-438A-BC45-04E54BFB17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BC3F7B-D741-4D05-BBF2-5A34102AB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823818-2C4B-4E11-BDB9-83C9E10BF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29AB8A-1BAC-4FF4-8188-4D6202866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618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11DC1C-C67C-433F-8F0E-D72AB1D515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92C243-0120-465F-9986-B71EA02F0E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C46FAD-8B11-400D-A67F-85DB0E148A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35B02B-9770-4B33-9A95-4B53BA28C9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992ECA-A990-4F41-AA3D-249E35081E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828ABAB-BF48-4B8B-8B09-C356D4B97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E6D7B3-0184-4BA5-8D2A-6EEE42BF0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45BCC2-D03B-46A7-BB53-E177B0614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794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B077CD-DCDF-4179-B628-83D60B5CAC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D7B464-1600-4CB5-9388-5A9CFD9C3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EFF6F6-8C46-42A5-999B-545DDF25F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65E8EF-FC01-483F-801A-28502D3E0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735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9DFABC-DA50-4BE1-ADD7-09223B7DD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F75A41-0E6B-43C8-9B86-2D8ABE4BA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BBCD89-77F4-47A1-81B7-B3AECF4C1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739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E7165E-4F39-48FF-8715-0D83BB5812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1459E7-0069-4F4C-BEB9-B559F4A830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7BC3BB-9421-4A39-B7D0-8287FEDDC1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DC1795-EE28-49A8-8E89-8E331F49E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879FA1-F2E1-4E5D-AB16-4206E8FA5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48613A-938D-4349-9983-6AA02A595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004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AC9AC-C10A-4444-89A8-4509942D1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D85644-06CE-44AF-9572-92F5AF4BD2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C7EFFF-E1B2-483A-B58B-759A685629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76FACF-3BC9-40B8-9C45-C8C49173A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C2455B-EC11-4BD9-8706-D83CD598F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6F93AB-1292-473C-8819-2344CE937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919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7C21BA-FFAD-4D5E-ABD6-B6E8B1A584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746154-796C-4AD6-BA42-3E50C8CC7D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C0A9B4-496D-40BE-9FF4-F77D3DC825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8454F0-2421-4942-8D8C-433D862BD113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FE7000-7B59-4AEB-8F33-F536E9D453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4569DF-119A-4AA9-A100-57321AFD56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8A2ACA-5E57-407B-A4BD-2CA35ADF3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437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>
            <a:extLst>
              <a:ext uri="{FF2B5EF4-FFF2-40B4-BE49-F238E27FC236}">
                <a16:creationId xmlns:a16="http://schemas.microsoft.com/office/drawing/2014/main" id="{E0C910FE-9FF6-4C1B-9C21-C172386CC6BA}"/>
              </a:ext>
            </a:extLst>
          </p:cNvPr>
          <p:cNvGrpSpPr/>
          <p:nvPr/>
        </p:nvGrpSpPr>
        <p:grpSpPr>
          <a:xfrm>
            <a:off x="549133" y="245868"/>
            <a:ext cx="5616146" cy="6148824"/>
            <a:chOff x="549133" y="245868"/>
            <a:chExt cx="5616146" cy="6148824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D0CF5992-DC30-4254-9D0D-8156E4090C91}"/>
                </a:ext>
              </a:extLst>
            </p:cNvPr>
            <p:cNvGrpSpPr/>
            <p:nvPr/>
          </p:nvGrpSpPr>
          <p:grpSpPr>
            <a:xfrm>
              <a:off x="549133" y="248972"/>
              <a:ext cx="5616146" cy="6145720"/>
              <a:chOff x="549133" y="248972"/>
              <a:chExt cx="5616146" cy="6145720"/>
            </a:xfrm>
          </p:grpSpPr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118819E4-14DB-406A-8DE4-02E1820088B4}"/>
                  </a:ext>
                </a:extLst>
              </p:cNvPr>
              <p:cNvGrpSpPr/>
              <p:nvPr/>
            </p:nvGrpSpPr>
            <p:grpSpPr>
              <a:xfrm>
                <a:off x="549133" y="248972"/>
                <a:ext cx="5559504" cy="2061893"/>
                <a:chOff x="549133" y="248972"/>
                <a:chExt cx="5559504" cy="2061893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10ACC0F7-27D1-4889-9A95-BADAC20EC131}"/>
                    </a:ext>
                  </a:extLst>
                </p:cNvPr>
                <p:cNvGrpSpPr/>
                <p:nvPr/>
              </p:nvGrpSpPr>
              <p:grpSpPr>
                <a:xfrm>
                  <a:off x="549133" y="248972"/>
                  <a:ext cx="1797355" cy="2019977"/>
                  <a:chOff x="568183" y="353747"/>
                  <a:chExt cx="1797355" cy="2019977"/>
                </a:xfrm>
              </p:grpSpPr>
              <p:pic>
                <p:nvPicPr>
                  <p:cNvPr id="5" name="Picture 4">
                    <a:extLst>
                      <a:ext uri="{FF2B5EF4-FFF2-40B4-BE49-F238E27FC236}">
                        <a16:creationId xmlns:a16="http://schemas.microsoft.com/office/drawing/2014/main" id="{C1727026-BD0D-4465-B44B-B9C95E0580E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68183" y="353747"/>
                    <a:ext cx="1797355" cy="1828800"/>
                  </a:xfrm>
                  <a:prstGeom prst="rect">
                    <a:avLst/>
                  </a:prstGeom>
                </p:spPr>
              </p:pic>
              <p:sp>
                <p:nvSpPr>
                  <p:cNvPr id="6" name="TextBox 5">
                    <a:extLst>
                      <a:ext uri="{FF2B5EF4-FFF2-40B4-BE49-F238E27FC236}">
                        <a16:creationId xmlns:a16="http://schemas.microsoft.com/office/drawing/2014/main" id="{9882FB54-33EB-400B-B64C-D28AE8CC290C}"/>
                      </a:ext>
                    </a:extLst>
                  </p:cNvPr>
                  <p:cNvSpPr txBox="1"/>
                  <p:nvPr/>
                </p:nvSpPr>
                <p:spPr>
                  <a:xfrm>
                    <a:off x="1290488" y="2173669"/>
                    <a:ext cx="60325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. max</a:t>
                    </a:r>
                  </a:p>
                </p:txBody>
              </p:sp>
            </p:grpSp>
            <p:sp>
              <p:nvSpPr>
                <p:cNvPr id="12" name="Rectangle 11">
                  <a:extLst>
                    <a:ext uri="{FF2B5EF4-FFF2-40B4-BE49-F238E27FC236}">
                      <a16:creationId xmlns:a16="http://schemas.microsoft.com/office/drawing/2014/main" id="{01FC05C8-2870-4F6C-802C-BA3AE5AD9E81}"/>
                    </a:ext>
                  </a:extLst>
                </p:cNvPr>
                <p:cNvSpPr/>
                <p:nvPr/>
              </p:nvSpPr>
              <p:spPr>
                <a:xfrm>
                  <a:off x="3094731" y="2110810"/>
                  <a:ext cx="705642" cy="20005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7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. </a:t>
                  </a:r>
                  <a:r>
                    <a:rPr lang="en-US" sz="7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rancatula</a:t>
                  </a:r>
                  <a:endParaRPr lang="en-US" sz="7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B94ED984-3AE0-4599-9828-0CB037594997}"/>
                    </a:ext>
                  </a:extLst>
                </p:cNvPr>
                <p:cNvGrpSpPr/>
                <p:nvPr/>
              </p:nvGrpSpPr>
              <p:grpSpPr>
                <a:xfrm>
                  <a:off x="4354820" y="293790"/>
                  <a:ext cx="1753817" cy="1946583"/>
                  <a:chOff x="4440545" y="427140"/>
                  <a:chExt cx="1753817" cy="1946583"/>
                </a:xfrm>
              </p:grpSpPr>
              <p:pic>
                <p:nvPicPr>
                  <p:cNvPr id="16" name="Picture 15">
                    <a:extLst>
                      <a:ext uri="{FF2B5EF4-FFF2-40B4-BE49-F238E27FC236}">
                        <a16:creationId xmlns:a16="http://schemas.microsoft.com/office/drawing/2014/main" id="{B3B7BFBD-EDF3-4683-859B-C8CE64FA260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440545" y="427140"/>
                    <a:ext cx="1753817" cy="1737360"/>
                  </a:xfrm>
                  <a:prstGeom prst="rect">
                    <a:avLst/>
                  </a:prstGeom>
                </p:spPr>
              </p:pic>
              <p:sp>
                <p:nvSpPr>
                  <p:cNvPr id="17" name="Rectangle 16">
                    <a:extLst>
                      <a:ext uri="{FF2B5EF4-FFF2-40B4-BE49-F238E27FC236}">
                        <a16:creationId xmlns:a16="http://schemas.microsoft.com/office/drawing/2014/main" id="{A74CE260-F70B-4025-94BB-B02D2CDF58A5}"/>
                      </a:ext>
                    </a:extLst>
                  </p:cNvPr>
                  <p:cNvSpPr/>
                  <p:nvPr/>
                </p:nvSpPr>
                <p:spPr>
                  <a:xfrm>
                    <a:off x="5135281" y="2173668"/>
                    <a:ext cx="604653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7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. sativum</a:t>
                    </a:r>
                  </a:p>
                </p:txBody>
              </p:sp>
            </p:grpSp>
          </p:grpSp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2812BF50-1017-4067-9028-F008F5584F77}"/>
                  </a:ext>
                </a:extLst>
              </p:cNvPr>
              <p:cNvGrpSpPr/>
              <p:nvPr/>
            </p:nvGrpSpPr>
            <p:grpSpPr>
              <a:xfrm>
                <a:off x="717419" y="2334392"/>
                <a:ext cx="5447860" cy="2028855"/>
                <a:chOff x="717419" y="2334392"/>
                <a:chExt cx="5447860" cy="2028855"/>
              </a:xfrm>
            </p:grpSpPr>
            <p:grpSp>
              <p:nvGrpSpPr>
                <p:cNvPr id="19" name="Group 18">
                  <a:extLst>
                    <a:ext uri="{FF2B5EF4-FFF2-40B4-BE49-F238E27FC236}">
                      <a16:creationId xmlns:a16="http://schemas.microsoft.com/office/drawing/2014/main" id="{1787BFD0-A1D2-4200-862E-777AEFB69CAC}"/>
                    </a:ext>
                  </a:extLst>
                </p:cNvPr>
                <p:cNvGrpSpPr/>
                <p:nvPr/>
              </p:nvGrpSpPr>
              <p:grpSpPr>
                <a:xfrm>
                  <a:off x="4500384" y="2334392"/>
                  <a:ext cx="1664895" cy="2028855"/>
                  <a:chOff x="6265386" y="2582042"/>
                  <a:chExt cx="1664895" cy="2028855"/>
                </a:xfrm>
              </p:grpSpPr>
              <p:pic>
                <p:nvPicPr>
                  <p:cNvPr id="8" name="Picture 7">
                    <a:extLst>
                      <a:ext uri="{FF2B5EF4-FFF2-40B4-BE49-F238E27FC236}">
                        <a16:creationId xmlns:a16="http://schemas.microsoft.com/office/drawing/2014/main" id="{4C1BB9F4-746B-4DEC-8D53-FB5C82385DD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265386" y="2582042"/>
                    <a:ext cx="1664895" cy="1828800"/>
                  </a:xfrm>
                  <a:prstGeom prst="rect">
                    <a:avLst/>
                  </a:prstGeom>
                </p:spPr>
              </p:pic>
              <p:sp>
                <p:nvSpPr>
                  <p:cNvPr id="9" name="Rectangle 8">
                    <a:extLst>
                      <a:ext uri="{FF2B5EF4-FFF2-40B4-BE49-F238E27FC236}">
                        <a16:creationId xmlns:a16="http://schemas.microsoft.com/office/drawing/2014/main" id="{C7EF6633-FEFD-420E-A2C2-89D53C02862B}"/>
                      </a:ext>
                    </a:extLst>
                  </p:cNvPr>
                  <p:cNvSpPr/>
                  <p:nvPr/>
                </p:nvSpPr>
                <p:spPr>
                  <a:xfrm>
                    <a:off x="6778163" y="4410842"/>
                    <a:ext cx="782587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7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. </a:t>
                    </a:r>
                    <a:r>
                      <a:rPr lang="en-US" sz="7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gustifolius</a:t>
                    </a:r>
                    <a:endParaRPr lang="en-US" sz="7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3" name="Group 22">
                  <a:extLst>
                    <a:ext uri="{FF2B5EF4-FFF2-40B4-BE49-F238E27FC236}">
                      <a16:creationId xmlns:a16="http://schemas.microsoft.com/office/drawing/2014/main" id="{0B71D44D-4885-462F-9EA6-969298E4AE83}"/>
                    </a:ext>
                  </a:extLst>
                </p:cNvPr>
                <p:cNvGrpSpPr/>
                <p:nvPr/>
              </p:nvGrpSpPr>
              <p:grpSpPr>
                <a:xfrm>
                  <a:off x="717419" y="2343917"/>
                  <a:ext cx="1680518" cy="2002536"/>
                  <a:chOff x="765044" y="2515367"/>
                  <a:chExt cx="1680518" cy="1991492"/>
                </a:xfrm>
              </p:grpSpPr>
              <p:pic>
                <p:nvPicPr>
                  <p:cNvPr id="21" name="Picture 20">
                    <a:extLst>
                      <a:ext uri="{FF2B5EF4-FFF2-40B4-BE49-F238E27FC236}">
                        <a16:creationId xmlns:a16="http://schemas.microsoft.com/office/drawing/2014/main" id="{59C84ED0-F8D7-493A-8CFF-053B6DA68E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65044" y="2515367"/>
                    <a:ext cx="1680518" cy="1920240"/>
                  </a:xfrm>
                  <a:prstGeom prst="rect">
                    <a:avLst/>
                  </a:prstGeom>
                </p:spPr>
              </p:pic>
              <p:sp>
                <p:nvSpPr>
                  <p:cNvPr id="22" name="Rectangle 21">
                    <a:extLst>
                      <a:ext uri="{FF2B5EF4-FFF2-40B4-BE49-F238E27FC236}">
                        <a16:creationId xmlns:a16="http://schemas.microsoft.com/office/drawing/2014/main" id="{9A82D837-EE37-4FDC-B787-78B1CA5A646D}"/>
                      </a:ext>
                    </a:extLst>
                  </p:cNvPr>
                  <p:cNvSpPr/>
                  <p:nvPr/>
                </p:nvSpPr>
                <p:spPr>
                  <a:xfrm>
                    <a:off x="1263766" y="4306804"/>
                    <a:ext cx="603050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7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. vulgaris</a:t>
                    </a:r>
                  </a:p>
                </p:txBody>
              </p:sp>
            </p:grpSp>
            <p:grpSp>
              <p:nvGrpSpPr>
                <p:cNvPr id="27" name="Group 26">
                  <a:extLst>
                    <a:ext uri="{FF2B5EF4-FFF2-40B4-BE49-F238E27FC236}">
                      <a16:creationId xmlns:a16="http://schemas.microsoft.com/office/drawing/2014/main" id="{8AA44B5A-48A6-4658-93BD-AAECCC575C78}"/>
                    </a:ext>
                  </a:extLst>
                </p:cNvPr>
                <p:cNvGrpSpPr/>
                <p:nvPr/>
              </p:nvGrpSpPr>
              <p:grpSpPr>
                <a:xfrm>
                  <a:off x="2425771" y="2343150"/>
                  <a:ext cx="1840297" cy="2011680"/>
                  <a:chOff x="2482921" y="2514600"/>
                  <a:chExt cx="1840297" cy="1992258"/>
                </a:xfrm>
              </p:grpSpPr>
              <p:pic>
                <p:nvPicPr>
                  <p:cNvPr id="25" name="Picture 24">
                    <a:extLst>
                      <a:ext uri="{FF2B5EF4-FFF2-40B4-BE49-F238E27FC236}">
                        <a16:creationId xmlns:a16="http://schemas.microsoft.com/office/drawing/2014/main" id="{E93A3145-A5B1-469B-AE2C-32C0A2F5C8C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482921" y="2514600"/>
                    <a:ext cx="1840297" cy="1811144"/>
                  </a:xfrm>
                  <a:prstGeom prst="rect">
                    <a:avLst/>
                  </a:prstGeom>
                </p:spPr>
              </p:pic>
              <p:sp>
                <p:nvSpPr>
                  <p:cNvPr id="26" name="Rectangle 25">
                    <a:extLst>
                      <a:ext uri="{FF2B5EF4-FFF2-40B4-BE49-F238E27FC236}">
                        <a16:creationId xmlns:a16="http://schemas.microsoft.com/office/drawing/2014/main" id="{901EC312-1E6F-4281-ABD9-E834F30FF5F8}"/>
                      </a:ext>
                    </a:extLst>
                  </p:cNvPr>
                  <p:cNvSpPr/>
                  <p:nvPr/>
                </p:nvSpPr>
                <p:spPr>
                  <a:xfrm>
                    <a:off x="3194756" y="4306803"/>
                    <a:ext cx="638316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7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. </a:t>
                    </a:r>
                    <a:r>
                      <a:rPr lang="en-US" sz="7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atense</a:t>
                    </a:r>
                    <a:endParaRPr lang="en-US" sz="7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53A27E7D-279F-4757-893A-957DEFF95A67}"/>
                  </a:ext>
                </a:extLst>
              </p:cNvPr>
              <p:cNvGrpSpPr/>
              <p:nvPr/>
            </p:nvGrpSpPr>
            <p:grpSpPr>
              <a:xfrm>
                <a:off x="559352" y="4326467"/>
                <a:ext cx="5560932" cy="2068225"/>
                <a:chOff x="559352" y="4326467"/>
                <a:chExt cx="5560932" cy="2068225"/>
              </a:xfrm>
            </p:grpSpPr>
            <p:grpSp>
              <p:nvGrpSpPr>
                <p:cNvPr id="42" name="Group 41">
                  <a:extLst>
                    <a:ext uri="{FF2B5EF4-FFF2-40B4-BE49-F238E27FC236}">
                      <a16:creationId xmlns:a16="http://schemas.microsoft.com/office/drawing/2014/main" id="{209EBD34-978F-42DB-9D04-9A17D166CC5B}"/>
                    </a:ext>
                  </a:extLst>
                </p:cNvPr>
                <p:cNvGrpSpPr/>
                <p:nvPr/>
              </p:nvGrpSpPr>
              <p:grpSpPr>
                <a:xfrm>
                  <a:off x="559352" y="4362662"/>
                  <a:ext cx="1872166" cy="2032029"/>
                  <a:chOff x="559352" y="4362662"/>
                  <a:chExt cx="1872166" cy="2032029"/>
                </a:xfrm>
              </p:grpSpPr>
              <p:pic>
                <p:nvPicPr>
                  <p:cNvPr id="31" name="Picture 30">
                    <a:extLst>
                      <a:ext uri="{FF2B5EF4-FFF2-40B4-BE49-F238E27FC236}">
                        <a16:creationId xmlns:a16="http://schemas.microsoft.com/office/drawing/2014/main" id="{AD11DEBF-B628-427F-A126-E1005C4A3C3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59352" y="4362662"/>
                    <a:ext cx="1872166" cy="1828800"/>
                  </a:xfrm>
                  <a:prstGeom prst="rect">
                    <a:avLst/>
                  </a:prstGeom>
                </p:spPr>
              </p:pic>
              <p:sp>
                <p:nvSpPr>
                  <p:cNvPr id="32" name="Rectangle 31">
                    <a:extLst>
                      <a:ext uri="{FF2B5EF4-FFF2-40B4-BE49-F238E27FC236}">
                        <a16:creationId xmlns:a16="http://schemas.microsoft.com/office/drawing/2014/main" id="{82FA57F7-C64B-45F8-A0A7-BD7A5455DDDC}"/>
                      </a:ext>
                    </a:extLst>
                  </p:cNvPr>
                  <p:cNvSpPr/>
                  <p:nvPr/>
                </p:nvSpPr>
                <p:spPr>
                  <a:xfrm>
                    <a:off x="1280942" y="6194636"/>
                    <a:ext cx="657552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7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. angularis</a:t>
                    </a:r>
                  </a:p>
                </p:txBody>
              </p:sp>
            </p:grp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983D12F1-79AA-4D15-A5D9-027C9C5A71CF}"/>
                    </a:ext>
                  </a:extLst>
                </p:cNvPr>
                <p:cNvGrpSpPr/>
                <p:nvPr/>
              </p:nvGrpSpPr>
              <p:grpSpPr>
                <a:xfrm>
                  <a:off x="2570543" y="4351652"/>
                  <a:ext cx="1746177" cy="2043040"/>
                  <a:chOff x="2570543" y="4351652"/>
                  <a:chExt cx="1746177" cy="2043040"/>
                </a:xfrm>
              </p:grpSpPr>
              <p:pic>
                <p:nvPicPr>
                  <p:cNvPr id="34" name="Picture 33">
                    <a:extLst>
                      <a:ext uri="{FF2B5EF4-FFF2-40B4-BE49-F238E27FC236}">
                        <a16:creationId xmlns:a16="http://schemas.microsoft.com/office/drawing/2014/main" id="{33001147-3D10-42AE-8897-20E8B769B5B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570543" y="4351652"/>
                    <a:ext cx="1746177" cy="1828800"/>
                  </a:xfrm>
                  <a:prstGeom prst="rect">
                    <a:avLst/>
                  </a:prstGeom>
                </p:spPr>
              </p:pic>
              <p:sp>
                <p:nvSpPr>
                  <p:cNvPr id="35" name="Rectangle 34">
                    <a:extLst>
                      <a:ext uri="{FF2B5EF4-FFF2-40B4-BE49-F238E27FC236}">
                        <a16:creationId xmlns:a16="http://schemas.microsoft.com/office/drawing/2014/main" id="{3C8232B4-1F25-4C0E-91FB-6F973D50E17F}"/>
                      </a:ext>
                    </a:extLst>
                  </p:cNvPr>
                  <p:cNvSpPr/>
                  <p:nvPr/>
                </p:nvSpPr>
                <p:spPr>
                  <a:xfrm>
                    <a:off x="3147638" y="6194637"/>
                    <a:ext cx="569387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7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. radiata</a:t>
                    </a:r>
                  </a:p>
                </p:txBody>
              </p:sp>
            </p:grpSp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id="{ECF60409-DF5B-4259-A8DA-B8F84545E470}"/>
                    </a:ext>
                  </a:extLst>
                </p:cNvPr>
                <p:cNvGrpSpPr/>
                <p:nvPr/>
              </p:nvGrpSpPr>
              <p:grpSpPr>
                <a:xfrm>
                  <a:off x="4528209" y="4326467"/>
                  <a:ext cx="1592075" cy="2068225"/>
                  <a:chOff x="4528209" y="4326467"/>
                  <a:chExt cx="1592075" cy="2068225"/>
                </a:xfrm>
              </p:grpSpPr>
              <p:pic>
                <p:nvPicPr>
                  <p:cNvPr id="37" name="Picture 36">
                    <a:extLst>
                      <a:ext uri="{FF2B5EF4-FFF2-40B4-BE49-F238E27FC236}">
                        <a16:creationId xmlns:a16="http://schemas.microsoft.com/office/drawing/2014/main" id="{046F3866-4289-44FC-8A71-80A1FF42408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528209" y="4326467"/>
                    <a:ext cx="1592075" cy="1920240"/>
                  </a:xfrm>
                  <a:prstGeom prst="rect">
                    <a:avLst/>
                  </a:prstGeom>
                </p:spPr>
              </p:pic>
              <p:sp>
                <p:nvSpPr>
                  <p:cNvPr id="39" name="Rectangle 38">
                    <a:extLst>
                      <a:ext uri="{FF2B5EF4-FFF2-40B4-BE49-F238E27FC236}">
                        <a16:creationId xmlns:a16="http://schemas.microsoft.com/office/drawing/2014/main" id="{C4C4C7BB-DC4D-41F0-A57E-E0EA0014CF61}"/>
                      </a:ext>
                    </a:extLst>
                  </p:cNvPr>
                  <p:cNvSpPr/>
                  <p:nvPr/>
                </p:nvSpPr>
                <p:spPr>
                  <a:xfrm>
                    <a:off x="4962805" y="6194637"/>
                    <a:ext cx="752129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7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. </a:t>
                    </a:r>
                    <a:r>
                      <a:rPr lang="en-US" sz="7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nguiculata</a:t>
                    </a:r>
                    <a:endParaRPr lang="en-US" sz="7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12B83CEF-8540-40B3-98C8-93B692F76FB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621739" y="245868"/>
              <a:ext cx="1622230" cy="1920240"/>
            </a:xfrm>
            <a:prstGeom prst="rect">
              <a:avLst/>
            </a:prstGeom>
          </p:spPr>
        </p:pic>
      </p:grpSp>
      <p:sp>
        <p:nvSpPr>
          <p:cNvPr id="49" name="Rectangle 48">
            <a:extLst>
              <a:ext uri="{FF2B5EF4-FFF2-40B4-BE49-F238E27FC236}">
                <a16:creationId xmlns:a16="http://schemas.microsoft.com/office/drawing/2014/main" id="{1124673A-FC76-4432-B89B-EE4B15AAEE53}"/>
              </a:ext>
            </a:extLst>
          </p:cNvPr>
          <p:cNvSpPr/>
          <p:nvPr/>
        </p:nvSpPr>
        <p:spPr>
          <a:xfrm>
            <a:off x="6664827" y="1886753"/>
            <a:ext cx="482346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200" b="1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5:</a:t>
            </a:r>
            <a:r>
              <a:rPr lang="en-US" sz="1200" b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eDonut</a:t>
            </a:r>
            <a:r>
              <a:rPr lang="en-US" sz="1200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agram showing distribution of L, N, and NL domain containing putative R proteins in 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ycine</a:t>
            </a:r>
            <a:r>
              <a:rPr lang="en-US" sz="1200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x</a:t>
            </a:r>
            <a:r>
              <a:rPr lang="en-US" sz="1200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dicago </a:t>
            </a:r>
            <a:r>
              <a:rPr lang="en-US" sz="1200" i="1" dirty="0" err="1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uncatula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isum sativum, Phaseolus vulgaris, </a:t>
            </a:r>
            <a:r>
              <a:rPr lang="en-US" sz="1200" i="1" dirty="0" err="1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ifolium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atense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 err="1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upinus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gustifolius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Vigna angularis, Vigna radiata,</a:t>
            </a:r>
            <a:r>
              <a:rPr lang="en-US" sz="1200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gna </a:t>
            </a:r>
            <a:r>
              <a:rPr lang="en-US" sz="1200" i="1" dirty="0" err="1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guiculata</a:t>
            </a:r>
            <a:r>
              <a:rPr lang="en-US" sz="1200" dirty="0">
                <a:solidFill>
                  <a:srgbClr val="1F497D"/>
                </a:solidFill>
                <a:latin typeface="Cambria" panose="020405030504060302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i="1" dirty="0">
              <a:solidFill>
                <a:srgbClr val="1F497D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5553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7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shal Singh Negi</dc:creator>
  <cp:lastModifiedBy>Vishal Singh Negi</cp:lastModifiedBy>
  <cp:revision>6</cp:revision>
  <dcterms:created xsi:type="dcterms:W3CDTF">2022-10-10T14:09:15Z</dcterms:created>
  <dcterms:modified xsi:type="dcterms:W3CDTF">2022-10-21T18:26:18Z</dcterms:modified>
</cp:coreProperties>
</file>